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101B2C-FCBA-4344-B1AE-6C8E3B41568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951E38-EA03-4C41-933A-7F81393A73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BC9D82-4018-48ED-A9A9-E363ABD9BCA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EA9C55-F326-4495-B692-798FB018C32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44745F-A5B4-42FB-843F-25295FABC4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14F6B0-53D4-4AD6-95E8-FD20A0F492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9C17D3-A9E9-487F-874B-00C4AA14B9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49CAD0-1993-4709-B11D-F06CB7FF8F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24C21E-CE27-4AE3-9900-89837191CB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02ED82-E83A-4BE0-8EBA-6E8DB7C7DA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510D5D-520D-4B00-9551-7840144518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CD7588-BF05-4103-95D1-E210ACF867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EBB0A9A-ED22-4824-AD17-6A3C6A804F9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24623" t="15701" r="29126" b="7137"/>
          <a:stretch/>
        </p:blipFill>
        <p:spPr>
          <a:xfrm>
            <a:off x="592200" y="1901880"/>
            <a:ext cx="2598840" cy="3238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2" name="Text Box 32"/>
          <p:cNvSpPr/>
          <p:nvPr/>
        </p:nvSpPr>
        <p:spPr>
          <a:xfrm>
            <a:off x="1447920" y="1589040"/>
            <a:ext cx="888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33"/>
          <p:cNvSpPr/>
          <p:nvPr/>
        </p:nvSpPr>
        <p:spPr>
          <a:xfrm>
            <a:off x="3914640" y="1589040"/>
            <a:ext cx="1511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HF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34"/>
          <p:cNvSpPr/>
          <p:nvPr/>
        </p:nvSpPr>
        <p:spPr>
          <a:xfrm>
            <a:off x="6697800" y="1589040"/>
            <a:ext cx="1511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HFD+T2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32"/>
          <p:cNvSpPr/>
          <p:nvPr/>
        </p:nvSpPr>
        <p:spPr>
          <a:xfrm>
            <a:off x="101520" y="1239840"/>
            <a:ext cx="889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90440" y="281160"/>
            <a:ext cx="87249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data 1. (A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Representative 2D-E Coomassie Blue stained maps of gastrocnemius muscle mitochondrial soluble proteins extracted from N, HFD, and HFD+T2 rats and separated on 17 cm/pH 3-10NL IPG strips in the first dimension and on 12% SDS-PAGE in the second one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B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uantitative data concerning differentially represented protein spots in HFD+T2 vs. HFD identified as non-mitochondrial structural proteins; spot numbers refer to Fig. 1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55680" y="2971800"/>
            <a:ext cx="216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55680" y="2368440"/>
            <a:ext cx="216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55680" y="4030560"/>
            <a:ext cx="216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55680" y="4535640"/>
            <a:ext cx="216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5560" y="2838600"/>
            <a:ext cx="44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5560" y="2228760"/>
            <a:ext cx="44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6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5560" y="3892680"/>
            <a:ext cx="44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5560" y="4397400"/>
            <a:ext cx="44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0" y="186696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317600" y="5319720"/>
            <a:ext cx="114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pI (NL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635040" y="5295960"/>
            <a:ext cx="2476440" cy="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55680" y="5181480"/>
            <a:ext cx="44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984400" y="5181480"/>
            <a:ext cx="44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" descr=""/>
          <p:cNvPicPr/>
          <p:nvPr/>
        </p:nvPicPr>
        <p:blipFill>
          <a:blip r:embed="rId2">
            <a:lum bright="6000"/>
          </a:blip>
          <a:stretch/>
        </p:blipFill>
        <p:spPr>
          <a:xfrm>
            <a:off x="3360600" y="1901880"/>
            <a:ext cx="2598840" cy="3238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1" name="" descr=""/>
          <p:cNvPicPr/>
          <p:nvPr/>
        </p:nvPicPr>
        <p:blipFill>
          <a:blip r:embed="rId3"/>
          <a:stretch/>
        </p:blipFill>
        <p:spPr>
          <a:xfrm>
            <a:off x="6143760" y="1901880"/>
            <a:ext cx="2598480" cy="3238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39600" y="96840"/>
            <a:ext cx="9047160" cy="6784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0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1-08T14:02:26Z</dcterms:created>
  <dc:creator>DSBA</dc:creator>
  <dc:description/>
  <dc:language>en-US</dc:language>
  <cp:lastModifiedBy>DSBA</cp:lastModifiedBy>
  <dcterms:modified xsi:type="dcterms:W3CDTF">2018-01-30T09:31:30Z</dcterms:modified>
  <cp:revision>58</cp:revision>
  <dc:subject/>
  <dc:title>Diapositiva 1</dc:title>
</cp:coreProperties>
</file>